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533869" y="1900246"/>
              <a:ext cx="4797341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533869" y="5384299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533869" y="4432520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533869" y="3480741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533869" y="2528962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870175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332594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4781720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6237493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533869" y="5860188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533869" y="4908409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533869" y="3956631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533869" y="3004852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533869" y="2053073"/>
              <a:ext cx="4797341" cy="0"/>
            </a:xfrm>
            <a:custGeom>
              <a:avLst/>
              <a:pathLst>
                <a:path w="4797341" h="0">
                  <a:moveTo>
                    <a:pt x="0" y="0"/>
                  </a:moveTo>
                  <a:lnTo>
                    <a:pt x="4797341" y="0"/>
                  </a:ln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8062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405383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5509607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428115" y="27111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428115" y="2711157"/>
              <a:ext cx="0" cy="1582950"/>
            </a:xfrm>
            <a:custGeom>
              <a:avLst/>
              <a:pathLst>
                <a:path w="0" h="1582950">
                  <a:moveTo>
                    <a:pt x="0" y="0"/>
                  </a:moveTo>
                  <a:lnTo>
                    <a:pt x="0" y="15829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428115" y="42941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501034" y="30263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501034" y="3026371"/>
              <a:ext cx="0" cy="1504029"/>
            </a:xfrm>
            <a:custGeom>
              <a:avLst/>
              <a:pathLst>
                <a:path w="0" h="1504029">
                  <a:moveTo>
                    <a:pt x="0" y="0"/>
                  </a:moveTo>
                  <a:lnTo>
                    <a:pt x="0" y="15040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501034" y="45304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2315001" y="4229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315001" y="4229334"/>
              <a:ext cx="0" cy="1585140"/>
            </a:xfrm>
            <a:custGeom>
              <a:avLst/>
              <a:pathLst>
                <a:path w="0" h="1585140">
                  <a:moveTo>
                    <a:pt x="0" y="0"/>
                  </a:moveTo>
                  <a:lnTo>
                    <a:pt x="0" y="15851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315001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5220083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5220083" y="2086637"/>
              <a:ext cx="0" cy="2035017"/>
            </a:xfrm>
            <a:custGeom>
              <a:avLst/>
              <a:pathLst>
                <a:path w="0" h="2035017">
                  <a:moveTo>
                    <a:pt x="0" y="0"/>
                  </a:moveTo>
                  <a:lnTo>
                    <a:pt x="0" y="203501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5220083" y="4121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3067170" y="38226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3067170" y="3822614"/>
              <a:ext cx="0" cy="1615406"/>
            </a:xfrm>
            <a:custGeom>
              <a:avLst/>
              <a:pathLst>
                <a:path w="0" h="1615406">
                  <a:moveTo>
                    <a:pt x="0" y="0"/>
                  </a:moveTo>
                  <a:lnTo>
                    <a:pt x="0" y="16154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3067170" y="54380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3672524" y="30598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3672524" y="3059860"/>
              <a:ext cx="0" cy="1692234"/>
            </a:xfrm>
            <a:custGeom>
              <a:avLst/>
              <a:pathLst>
                <a:path w="0" h="1692234">
                  <a:moveTo>
                    <a:pt x="0" y="0"/>
                  </a:moveTo>
                  <a:lnTo>
                    <a:pt x="0" y="16922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3672524" y="4752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993726" y="33704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993726" y="3370411"/>
              <a:ext cx="0" cy="1611409"/>
            </a:xfrm>
            <a:custGeom>
              <a:avLst/>
              <a:pathLst>
                <a:path w="0" h="1611409">
                  <a:moveTo>
                    <a:pt x="0" y="0"/>
                  </a:moveTo>
                  <a:lnTo>
                    <a:pt x="0" y="16114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993726" y="49818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911227" y="35397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911227" y="3539759"/>
              <a:ext cx="0" cy="2068462"/>
            </a:xfrm>
            <a:custGeom>
              <a:avLst/>
              <a:pathLst>
                <a:path w="0" h="2068462">
                  <a:moveTo>
                    <a:pt x="0" y="0"/>
                  </a:moveTo>
                  <a:lnTo>
                    <a:pt x="0" y="20684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911227" y="56082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3015251" y="35026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1840978" y="3502632"/>
              <a:ext cx="1174272" cy="0"/>
            </a:xfrm>
            <a:custGeom>
              <a:avLst/>
              <a:pathLst>
                <a:path w="1174272" h="0">
                  <a:moveTo>
                    <a:pt x="117427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1840978" y="35026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3086125" y="3778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915943" y="3778386"/>
              <a:ext cx="1170181" cy="0"/>
            </a:xfrm>
            <a:custGeom>
              <a:avLst/>
              <a:pathLst>
                <a:path w="1170181" h="0">
                  <a:moveTo>
                    <a:pt x="117018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915943" y="3778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878072" y="50219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1751930" y="5021904"/>
              <a:ext cx="1126141" cy="0"/>
            </a:xfrm>
            <a:custGeom>
              <a:avLst/>
              <a:pathLst>
                <a:path w="1126141" h="0">
                  <a:moveTo>
                    <a:pt x="11261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1751930" y="50219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6113149" y="31041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4327016" y="3104146"/>
              <a:ext cx="1786133" cy="0"/>
            </a:xfrm>
            <a:custGeom>
              <a:avLst/>
              <a:pathLst>
                <a:path w="1786133" h="0">
                  <a:moveTo>
                    <a:pt x="17861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4327016" y="31041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3648305" y="46303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486034" y="4630317"/>
              <a:ext cx="1162271" cy="0"/>
            </a:xfrm>
            <a:custGeom>
              <a:avLst/>
              <a:pathLst>
                <a:path w="1162271" h="0">
                  <a:moveTo>
                    <a:pt x="116227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486034" y="46303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4302147" y="39059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3042901" y="3905977"/>
              <a:ext cx="1259246" cy="0"/>
            </a:xfrm>
            <a:custGeom>
              <a:avLst/>
              <a:pathLst>
                <a:path w="1259246" h="0">
                  <a:moveTo>
                    <a:pt x="125924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3042901" y="39059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3571602" y="41761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415850" y="4176116"/>
              <a:ext cx="1155752" cy="0"/>
            </a:xfrm>
            <a:custGeom>
              <a:avLst/>
              <a:pathLst>
                <a:path w="1155752" h="0">
                  <a:moveTo>
                    <a:pt x="115575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415850" y="41761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3602042" y="4573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220412" y="4573990"/>
              <a:ext cx="1381629" cy="0"/>
            </a:xfrm>
            <a:custGeom>
              <a:avLst/>
              <a:pathLst>
                <a:path w="1381629" h="0">
                  <a:moveTo>
                    <a:pt x="138162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220412" y="4573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t70"/>
            <p:cNvSpPr/>
            <p:nvPr/>
          </p:nvSpPr>
          <p:spPr>
            <a:xfrm>
              <a:off x="2403289" y="34778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t71"/>
            <p:cNvSpPr/>
            <p:nvPr/>
          </p:nvSpPr>
          <p:spPr>
            <a:xfrm>
              <a:off x="2476208" y="37535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t72"/>
            <p:cNvSpPr/>
            <p:nvPr/>
          </p:nvSpPr>
          <p:spPr>
            <a:xfrm>
              <a:off x="2290175" y="49970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t73"/>
            <p:cNvSpPr/>
            <p:nvPr/>
          </p:nvSpPr>
          <p:spPr>
            <a:xfrm>
              <a:off x="5195257" y="30793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t74"/>
            <p:cNvSpPr/>
            <p:nvPr/>
          </p:nvSpPr>
          <p:spPr>
            <a:xfrm>
              <a:off x="3042344" y="46054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t75"/>
            <p:cNvSpPr/>
            <p:nvPr/>
          </p:nvSpPr>
          <p:spPr>
            <a:xfrm>
              <a:off x="3647698" y="38811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t76"/>
            <p:cNvSpPr/>
            <p:nvPr/>
          </p:nvSpPr>
          <p:spPr>
            <a:xfrm>
              <a:off x="2968900" y="41512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t77"/>
            <p:cNvSpPr/>
            <p:nvPr/>
          </p:nvSpPr>
          <p:spPr>
            <a:xfrm>
              <a:off x="2886401" y="45491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533869" y="3272718"/>
              <a:ext cx="4797341" cy="1180937"/>
            </a:xfrm>
            <a:custGeom>
              <a:avLst/>
              <a:pathLst>
                <a:path w="4797341" h="1180937">
                  <a:moveTo>
                    <a:pt x="0" y="1180937"/>
                  </a:move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1533869" y="2951947"/>
              <a:ext cx="4797341" cy="1673467"/>
            </a:xfrm>
            <a:custGeom>
              <a:avLst/>
              <a:pathLst>
                <a:path w="4797341" h="1673467">
                  <a:moveTo>
                    <a:pt x="0" y="1673467"/>
                  </a:move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1533869" y="3258312"/>
              <a:ext cx="4797341" cy="1191338"/>
            </a:xfrm>
            <a:custGeom>
              <a:avLst/>
              <a:pathLst>
                <a:path w="4797341" h="1191338">
                  <a:moveTo>
                    <a:pt x="0" y="1191338"/>
                  </a:move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1533869" y="3121324"/>
              <a:ext cx="4797341" cy="1290241"/>
            </a:xfrm>
            <a:custGeom>
              <a:avLst/>
              <a:pathLst>
                <a:path w="4797341" h="1290241">
                  <a:moveTo>
                    <a:pt x="0" y="1290241"/>
                  </a:moveTo>
                  <a:lnTo>
                    <a:pt x="4797341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tx82"/>
            <p:cNvSpPr/>
            <p:nvPr/>
          </p:nvSpPr>
          <p:spPr>
            <a:xfrm>
              <a:off x="1148183" y="5818496"/>
              <a:ext cx="323056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2e-04</a:t>
              </a:r>
            </a:p>
          </p:txBody>
        </p:sp>
        <p:sp>
          <p:nvSpPr>
            <p:cNvPr id="84" name="tx83"/>
            <p:cNvSpPr/>
            <p:nvPr/>
          </p:nvSpPr>
          <p:spPr>
            <a:xfrm>
              <a:off x="1157351" y="4866718"/>
              <a:ext cx="31388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e+00</a:t>
              </a:r>
            </a:p>
          </p:txBody>
        </p:sp>
        <p:sp>
          <p:nvSpPr>
            <p:cNvPr id="85" name="tx84"/>
            <p:cNvSpPr/>
            <p:nvPr/>
          </p:nvSpPr>
          <p:spPr>
            <a:xfrm>
              <a:off x="1185400" y="3914939"/>
              <a:ext cx="28583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e-04</a:t>
              </a:r>
            </a:p>
          </p:txBody>
        </p:sp>
        <p:sp>
          <p:nvSpPr>
            <p:cNvPr id="86" name="tx85"/>
            <p:cNvSpPr/>
            <p:nvPr/>
          </p:nvSpPr>
          <p:spPr>
            <a:xfrm>
              <a:off x="1185400" y="2963160"/>
              <a:ext cx="28583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e-04</a:t>
              </a:r>
            </a:p>
          </p:txBody>
        </p:sp>
        <p:sp>
          <p:nvSpPr>
            <p:cNvPr id="87" name="tx86"/>
            <p:cNvSpPr/>
            <p:nvPr/>
          </p:nvSpPr>
          <p:spPr>
            <a:xfrm>
              <a:off x="1185400" y="2011381"/>
              <a:ext cx="28583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e-04</a:t>
              </a:r>
            </a:p>
          </p:txBody>
        </p:sp>
        <p:sp>
          <p:nvSpPr>
            <p:cNvPr id="88" name="pl87"/>
            <p:cNvSpPr/>
            <p:nvPr/>
          </p:nvSpPr>
          <p:spPr>
            <a:xfrm>
              <a:off x="1499075" y="58601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1499075" y="49084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1499075" y="39566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499075" y="30048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499075" y="20530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598062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4053834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5509607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tx95"/>
            <p:cNvSpPr/>
            <p:nvPr/>
          </p:nvSpPr>
          <p:spPr>
            <a:xfrm>
              <a:off x="2520381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97" name="tx96"/>
            <p:cNvSpPr/>
            <p:nvPr/>
          </p:nvSpPr>
          <p:spPr>
            <a:xfrm>
              <a:off x="3976153" y="6061750"/>
              <a:ext cx="155361" cy="8174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98" name="tx97"/>
            <p:cNvSpPr/>
            <p:nvPr/>
          </p:nvSpPr>
          <p:spPr>
            <a:xfrm>
              <a:off x="5431926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99" name="tx98"/>
            <p:cNvSpPr/>
            <p:nvPr/>
          </p:nvSpPr>
          <p:spPr>
            <a:xfrm>
              <a:off x="1357060" y="6170706"/>
              <a:ext cx="5150960" cy="13110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Hidradenitis suppurativa || id:finngen_R12_L12_HIDRADENITISSUP</a:t>
              </a:r>
            </a:p>
          </p:txBody>
        </p:sp>
        <p:sp>
          <p:nvSpPr>
            <p:cNvPr id="100" name="tx99"/>
            <p:cNvSpPr/>
            <p:nvPr/>
          </p:nvSpPr>
          <p:spPr>
            <a:xfrm rot="-5400000">
              <a:off x="-1339751" y="3884969"/>
              <a:ext cx="4716307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Operation code: pilonidal sinus surgery (anal) || id:ukb-b-5617</a:t>
              </a:r>
            </a:p>
          </p:txBody>
        </p:sp>
        <p:sp>
          <p:nvSpPr>
            <p:cNvPr id="101" name="rc100"/>
            <p:cNvSpPr/>
            <p:nvPr/>
          </p:nvSpPr>
          <p:spPr>
            <a:xfrm>
              <a:off x="2455045" y="983989"/>
              <a:ext cx="2954990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02" name="tx101"/>
            <p:cNvSpPr/>
            <p:nvPr/>
          </p:nvSpPr>
          <p:spPr>
            <a:xfrm>
              <a:off x="2524634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103" name="rc102"/>
            <p:cNvSpPr/>
            <p:nvPr/>
          </p:nvSpPr>
          <p:spPr>
            <a:xfrm>
              <a:off x="2524634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2524634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rc104"/>
            <p:cNvSpPr/>
            <p:nvPr/>
          </p:nvSpPr>
          <p:spPr>
            <a:xfrm>
              <a:off x="2524634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2524634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rc106"/>
            <p:cNvSpPr/>
            <p:nvPr/>
          </p:nvSpPr>
          <p:spPr>
            <a:xfrm>
              <a:off x="4181659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4181659" y="1252566"/>
              <a:ext cx="219455" cy="219455"/>
            </a:xfrm>
            <a:custGeom>
              <a:av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rc108"/>
            <p:cNvSpPr/>
            <p:nvPr/>
          </p:nvSpPr>
          <p:spPr>
            <a:xfrm>
              <a:off x="4181659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4181659" y="1472022"/>
              <a:ext cx="219455" cy="219456"/>
            </a:xfrm>
            <a:custGeom>
              <a:av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tx110"/>
            <p:cNvSpPr/>
            <p:nvPr/>
          </p:nvSpPr>
          <p:spPr>
            <a:xfrm>
              <a:off x="2813679" y="1298775"/>
              <a:ext cx="129839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</a:t>
              </a:r>
            </a:p>
          </p:txBody>
        </p:sp>
        <p:sp>
          <p:nvSpPr>
            <p:cNvPr id="112" name="tx111"/>
            <p:cNvSpPr/>
            <p:nvPr/>
          </p:nvSpPr>
          <p:spPr>
            <a:xfrm>
              <a:off x="2813679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113" name="tx112"/>
            <p:cNvSpPr/>
            <p:nvPr/>
          </p:nvSpPr>
          <p:spPr>
            <a:xfrm>
              <a:off x="4470704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114" name="tx113"/>
            <p:cNvSpPr/>
            <p:nvPr/>
          </p:nvSpPr>
          <p:spPr>
            <a:xfrm>
              <a:off x="4470704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11-08T20:47:19Z</dcterms:modified>
  <cp:category/>
</cp:coreProperties>
</file>